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58"/>
  </p:normalViewPr>
  <p:slideViewPr>
    <p:cSldViewPr snapToGrid="0">
      <p:cViewPr varScale="1">
        <p:scale>
          <a:sx n="104" d="100"/>
          <a:sy n="104" d="100"/>
        </p:scale>
        <p:origin x="232" y="5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9C3197-EA2E-6D6C-F94C-72CA642475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B42433D-2236-4919-B0FB-A09AB5A75ED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DC486F-A150-9534-894C-52559852E4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1F14A-D86A-0B4C-B31A-8777B07BE6A4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BD34A0-09B0-F721-6B92-100C64B496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EE714D-F9F0-2491-2F6F-DB3939EA90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CB6C9-AE35-D74B-827C-35F59A33B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0507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9E2B4C-C516-1EB8-B609-FC31700605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1F5BDD-AD38-1A8F-F7A2-90052E1CBE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931CDD-542E-5061-5F7A-7AEB8CA05D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1F14A-D86A-0B4C-B31A-8777B07BE6A4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DF5F6B-25AD-E517-67CF-92023A96B8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B6AEE3-62EF-F9DE-85DD-93B828F336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CB6C9-AE35-D74B-827C-35F59A33B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8573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7F389A1-FCD2-DB13-298D-B2F962C933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3398D4-8351-D385-13C2-790CA989CD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7CA3DE-CE73-C31D-3013-DE3F5E654F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1F14A-D86A-0B4C-B31A-8777B07BE6A4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0215CA-5BB9-AACF-3D94-8A439C5321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AF0CC0-D51F-BCBA-D223-F488EB80A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CB6C9-AE35-D74B-827C-35F59A33B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425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EB0DFE-FE94-F5FB-3E87-190AB8581F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C82B46-3083-B0E8-7DA3-47E52617EA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9E1D6A-F371-3414-00DD-8740989BBE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1F14A-D86A-0B4C-B31A-8777B07BE6A4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4C56C0-B9FC-B7D8-CEEE-A13F84CEE1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47332C-61BD-FB6C-CE31-C26588E856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CB6C9-AE35-D74B-827C-35F59A33B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799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FD9A7C-F9EE-6496-54A9-222504FEA6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01FDFD-676A-1654-6607-294981D5E7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922808-66A8-B39D-DE13-66246AD230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1F14A-D86A-0B4C-B31A-8777B07BE6A4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554AC9-DC50-6178-851B-2C034635D1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722CC2-8AAF-A057-79B1-FCF257683A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CB6C9-AE35-D74B-827C-35F59A33B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036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FD0045-4049-BCA8-8C9D-3FF1B93BE1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850D69-F430-B3D1-BEDD-8BE7B0565FB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54EFE3-4FB5-5D57-E169-B51148C07B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BF1C78-970C-446B-8E92-867B2DB02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1F14A-D86A-0B4C-B31A-8777B07BE6A4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2B8C03-90F1-7A48-C934-CC6228CB87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E6009F-81CA-CE5F-6959-76AF831421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CB6C9-AE35-D74B-827C-35F59A33B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830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3E48A8-A69D-EB40-5C5C-51CACD80BC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2C9D3B-E474-80F9-49DD-F6EB0CE9CE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587D49-155D-6EBF-73E3-9D6001C924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E8D27B7-7276-C8D9-BCD6-EBB94C09B7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018C137-C42B-72AE-4D3D-DFB1D0A33D0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A3D74A-147D-C62E-DAE4-EC80C830A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1F14A-D86A-0B4C-B31A-8777B07BE6A4}" type="datetimeFigureOut">
              <a:rPr lang="en-US" smtClean="0"/>
              <a:t>11/7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C1C3F08-4BC0-91D0-F8AC-56D07115EF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8E8B0C9-B304-FC1F-DB3C-0D2FA41EAD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CB6C9-AE35-D74B-827C-35F59A33B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8777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E97E66-BBB8-F210-5E6D-0826180234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0460FD-6EC3-B759-1E96-CF13F839B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1F14A-D86A-0B4C-B31A-8777B07BE6A4}" type="datetimeFigureOut">
              <a:rPr lang="en-US" smtClean="0"/>
              <a:t>11/7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2F7554C-8BE9-825C-96E8-494B8C65F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256E006-6A93-8E20-9562-1108A440E7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CB6C9-AE35-D74B-827C-35F59A33B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727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39F391-2F9B-D179-5514-ADD33CCAC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1F14A-D86A-0B4C-B31A-8777B07BE6A4}" type="datetimeFigureOut">
              <a:rPr lang="en-US" smtClean="0"/>
              <a:t>11/7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86D01CE-74A9-5D18-2BEB-D599D1669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8FCA8C4-1A44-2BA1-F056-CCD02EC3BB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CB6C9-AE35-D74B-827C-35F59A33B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9967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824719-EBAE-FDC6-5C14-AAAF97258D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12B75F-7D59-4764-3033-D666F8467C6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D0BF8F-EB49-5084-BBAC-CFB913BBE1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82ED52-316C-8B1F-8C6A-70915434C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1F14A-D86A-0B4C-B31A-8777B07BE6A4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D8352E-CA04-B881-D7FF-39F5128C19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97FFAD-44F6-659A-BCBC-CE0CB6BD8B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CB6C9-AE35-D74B-827C-35F59A33B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1598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189BA6-776F-27A9-3B4A-2FAFCEF231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656A458-D8EB-8261-4AB7-5D69FAD436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BD68D61-28BF-08BD-3999-251C1777A4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962FC1-CADA-B1F2-45BA-5B7F1467D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71F14A-D86A-0B4C-B31A-8777B07BE6A4}" type="datetimeFigureOut">
              <a:rPr lang="en-US" smtClean="0"/>
              <a:t>11/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98F308-4EC0-1BE8-0DCF-1A9BD6DD43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608E7F-7A2E-CF20-DDF0-3AAFF4469F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CB6C9-AE35-D74B-827C-35F59A33B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401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100B008-9B27-74B0-42A2-67D3475B8A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AB0798-C302-1031-3A6C-CDAAEC5E07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E6B243-C938-2457-7A79-62466F6158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71F14A-D86A-0B4C-B31A-8777B07BE6A4}" type="datetimeFigureOut">
              <a:rPr lang="en-US" smtClean="0"/>
              <a:t>11/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39E60A-ECF1-9B7A-C704-8AB7C0464A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CF55D0-59D0-C4A0-F4B6-C3466B04C1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7CB6C9-AE35-D74B-827C-35F59A33B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866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ifferent types of food on a white background&#10;&#10;AI-generated content may be incorrect.">
            <a:extLst>
              <a:ext uri="{FF2B5EF4-FFF2-40B4-BE49-F238E27FC236}">
                <a16:creationId xmlns:a16="http://schemas.microsoft.com/office/drawing/2014/main" id="{F08CA4C8-C002-C4E6-0140-3141C9E80A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0308" y="413924"/>
            <a:ext cx="7968880" cy="60301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22508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7F999A39-FB13-5ABB-85B5-B768072B4BA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640817"/>
              </p:ext>
            </p:extLst>
          </p:nvPr>
        </p:nvGraphicFramePr>
        <p:xfrm>
          <a:off x="2051223" y="817879"/>
          <a:ext cx="8725242" cy="520988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82785">
                  <a:extLst>
                    <a:ext uri="{9D8B030D-6E8A-4147-A177-3AD203B41FA5}">
                      <a16:colId xmlns:a16="http://schemas.microsoft.com/office/drawing/2014/main" val="3828363248"/>
                    </a:ext>
                  </a:extLst>
                </a:gridCol>
                <a:gridCol w="1644825">
                  <a:extLst>
                    <a:ext uri="{9D8B030D-6E8A-4147-A177-3AD203B41FA5}">
                      <a16:colId xmlns:a16="http://schemas.microsoft.com/office/drawing/2014/main" val="579092492"/>
                    </a:ext>
                  </a:extLst>
                </a:gridCol>
                <a:gridCol w="4897632">
                  <a:extLst>
                    <a:ext uri="{9D8B030D-6E8A-4147-A177-3AD203B41FA5}">
                      <a16:colId xmlns:a16="http://schemas.microsoft.com/office/drawing/2014/main" val="1954308322"/>
                    </a:ext>
                  </a:extLst>
                </a:gridCol>
              </a:tblGrid>
              <a:tr h="370724">
                <a:tc gridSpan="3"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Bristol Stool Scale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40028209"/>
                  </a:ext>
                </a:extLst>
              </a:tr>
              <a:tr h="366086"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Appearanc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Type/Grad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/>
                        <a:t>Descriptio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09990782"/>
                  </a:ext>
                </a:extLst>
              </a:tr>
              <a:tr h="639011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ype 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eparate hard lump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5703193"/>
                  </a:ext>
                </a:extLst>
              </a:tr>
              <a:tr h="639011"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ype 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Lumpy and sausage-like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28006428"/>
                  </a:ext>
                </a:extLst>
              </a:tr>
              <a:tr h="639011"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ype 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A sausage shape with cracks in the surface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72140504"/>
                  </a:ext>
                </a:extLst>
              </a:tr>
              <a:tr h="639011"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ype 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Like a smooth, soft sausage or snake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908625438"/>
                  </a:ext>
                </a:extLst>
              </a:tr>
              <a:tr h="639011"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ype 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oft blobs with clear-cut edge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29620544"/>
                  </a:ext>
                </a:extLst>
              </a:tr>
              <a:tr h="639011"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ype 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Mushy consistency with ragged edge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33984946"/>
                  </a:ext>
                </a:extLst>
              </a:tr>
              <a:tr h="639011">
                <a:tc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ype 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Liquid consistency with no solid piece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17017033"/>
                  </a:ext>
                </a:extLst>
              </a:tr>
            </a:tbl>
          </a:graphicData>
        </a:graphic>
      </p:graphicFrame>
      <p:pic>
        <p:nvPicPr>
          <p:cNvPr id="2" name="Picture 1" descr="Different types of food on a white background&#10;&#10;AI-generated content may be incorrect.">
            <a:extLst>
              <a:ext uri="{FF2B5EF4-FFF2-40B4-BE49-F238E27FC236}">
                <a16:creationId xmlns:a16="http://schemas.microsoft.com/office/drawing/2014/main" id="{AA31B147-B5A5-F253-4983-E89D8B3ED7D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735" t="1947" r="71663" b="2767"/>
          <a:stretch>
            <a:fillRect/>
          </a:stretch>
        </p:blipFill>
        <p:spPr>
          <a:xfrm>
            <a:off x="2051223" y="1584753"/>
            <a:ext cx="2156404" cy="444301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1364727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60</Words>
  <Application>Microsoft Macintosh PowerPoint</Application>
  <PresentationFormat>Widescreen</PresentationFormat>
  <Paragraphs>1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rees, Zachary</dc:creator>
  <cp:lastModifiedBy>Crees, Zachary</cp:lastModifiedBy>
  <cp:revision>2</cp:revision>
  <dcterms:created xsi:type="dcterms:W3CDTF">2025-10-24T05:03:58Z</dcterms:created>
  <dcterms:modified xsi:type="dcterms:W3CDTF">2025-11-07T14:14:38Z</dcterms:modified>
</cp:coreProperties>
</file>